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>
        <p:scale>
          <a:sx n="150" d="100"/>
          <a:sy n="150" d="100"/>
        </p:scale>
        <p:origin x="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503071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7341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29060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48067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85547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66072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09057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30446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92369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15780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66784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3F0CF-CE64-4FBD-904C-97A274E3D908}" type="datetimeFigureOut">
              <a:rPr lang="fr-CH" smtClean="0"/>
              <a:t>13.05.2016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91818-8CEE-4AF5-A047-C7C9FB0A690E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35910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0424" y="899191"/>
            <a:ext cx="5432870" cy="7619048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00733" y="609226"/>
            <a:ext cx="454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.</a:t>
            </a:r>
            <a:endParaRPr lang="en-US" sz="2400" b="1" dirty="0"/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943027" y="739035"/>
            <a:ext cx="0" cy="776469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970797" y="701559"/>
            <a:ext cx="17987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Individual SNV frequency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223029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8991" y="737623"/>
            <a:ext cx="5399451" cy="352537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00733" y="609226"/>
            <a:ext cx="4546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2400" b="1" dirty="0" smtClean="0"/>
              <a:t>B.</a:t>
            </a:r>
            <a:endParaRPr lang="fr-CH" sz="2400" b="1" dirty="0"/>
          </a:p>
        </p:txBody>
      </p:sp>
      <p:sp>
        <p:nvSpPr>
          <p:cNvPr id="2" name="Rectangle 1"/>
          <p:cNvSpPr/>
          <p:nvPr/>
        </p:nvSpPr>
        <p:spPr>
          <a:xfrm>
            <a:off x="2014538" y="2447925"/>
            <a:ext cx="204787" cy="319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" name="Rectangle 12"/>
          <p:cNvSpPr/>
          <p:nvPr/>
        </p:nvSpPr>
        <p:spPr>
          <a:xfrm>
            <a:off x="5582270" y="2447924"/>
            <a:ext cx="204787" cy="4667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1323744" y="4343728"/>
            <a:ext cx="4677006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323744" y="4354872"/>
            <a:ext cx="4677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mtDNA position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323744" y="922866"/>
            <a:ext cx="3343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Deviation from the theoretical SNV frequency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914729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8</TotalTime>
  <Words>15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Nest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quis,Julien,LAUSANNE,Functional Genomics</dc:creator>
  <cp:lastModifiedBy>Marquis,Julien,LAUSANNE,Functional Genomics</cp:lastModifiedBy>
  <cp:revision>8</cp:revision>
  <dcterms:created xsi:type="dcterms:W3CDTF">2016-05-13T10:38:43Z</dcterms:created>
  <dcterms:modified xsi:type="dcterms:W3CDTF">2016-05-13T17:01:34Z</dcterms:modified>
</cp:coreProperties>
</file>